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018970-69D7-4F95-B454-147F0ABBF1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3D4783-F41E-434F-A018-C6A5FE62BF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A118E9-BD95-4579-B068-7FBBBEB4317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2CC324-FA3C-43F1-A302-5BF69202AF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CB3076-94B7-4C3D-9B8E-C3AEA45910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7CD6EA-2CF3-4D71-ABB5-86CFF5749A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C6CB82-A676-4F86-83CC-A87738F40B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8125E-D9E5-4F41-91E1-A675879CD0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2045ED-D135-4542-8447-719E84BE8C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4FE50B-952C-40B1-8A6A-726DD05A60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AD3F8-74EF-4B47-9135-E98F7B29FD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D45EBC-EDEA-4AC1-BBB8-6068F07868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CA2279-D2F1-491E-B9D4-7CE01FA129C0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F:\MGG-Sorghum_propinquum_MS\MGG-Sorghum propinquum MS\Online Resource 9 An overview of rhizome tip up regulated genes in Sorghum propinquum and O. longistaminata mapped to major metabolic pathways in rice.tif"/>
          <p:cNvPicPr/>
          <p:nvPr/>
        </p:nvPicPr>
        <p:blipFill>
          <a:blip r:embed="rId1"/>
          <a:stretch/>
        </p:blipFill>
        <p:spPr>
          <a:xfrm>
            <a:off x="52560" y="642960"/>
            <a:ext cx="9091440" cy="3017880"/>
          </a:xfrm>
          <a:prstGeom prst="rect">
            <a:avLst/>
          </a:prstGeom>
          <a:ln w="0">
            <a:noFill/>
          </a:ln>
        </p:spPr>
      </p:pic>
      <p:sp>
        <p:nvSpPr>
          <p:cNvPr id="42" name="矩形 3"/>
          <p:cNvSpPr/>
          <p:nvPr/>
        </p:nvSpPr>
        <p:spPr>
          <a:xfrm>
            <a:off x="108000" y="3811680"/>
            <a:ext cx="903600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An overview of rhizome tip up regulated genes in </a:t>
            </a:r>
            <a:r>
              <a:rPr b="1" i="1" lang="en-US" sz="1600" spc="-1" strike="noStrike">
                <a:solidFill>
                  <a:srgbClr val="000000"/>
                </a:solidFill>
                <a:latin typeface="Times New Roman"/>
              </a:rPr>
              <a:t>Sorghum propinquum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1" i="1" lang="en-US" sz="1600" spc="-1" strike="noStrike">
                <a:solidFill>
                  <a:srgbClr val="000000"/>
                </a:solidFill>
                <a:latin typeface="Times New Roman"/>
              </a:rPr>
              <a:t>O. longistaminata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 mapped to major metabolic pathways in rice (</a:t>
            </a:r>
            <a:r>
              <a:rPr b="1" i="1" lang="en-US" sz="1600" spc="-1" strike="noStrike">
                <a:solidFill>
                  <a:srgbClr val="000000"/>
                </a:solidFill>
                <a:latin typeface="Times New Roman"/>
              </a:rPr>
              <a:t>ssp. japonica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).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Total 1,885 up regulated genes were mapped to metabolic pathways. Black dots indicate compounds within pathways. Reactions with cycling genes are colored in red. Pathways with predominant mappings of </a:t>
            </a: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up regulated genes such as carbohydrates biosynthesis, amino acids biosynthesis, glycolysis, fermentation, carbohydrates degradation, hormones biosynthesis and fatty acids and lipids biosynthesis are cycled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24T03:06:10Z</dcterms:created>
  <dc:creator>tingwing</dc:creator>
  <dc:description/>
  <dc:language>en-US</dc:language>
  <cp:lastModifiedBy>Kate</cp:lastModifiedBy>
  <dcterms:modified xsi:type="dcterms:W3CDTF">2013-01-20T19:54:21Z</dcterms:modified>
  <cp:revision>3</cp:revision>
  <dc:subject/>
  <dc:title>PowerPoint 演示文稿</dc:title>
</cp:coreProperties>
</file>